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05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13;g10f1fdb07ad_0_0"/>
          <p:cNvSpPr txBox="1"/>
          <p:nvPr/>
        </p:nvSpPr>
        <p:spPr bwMode="auto">
          <a:xfrm>
            <a:off x="2194547" y="4642347"/>
            <a:ext cx="8429265" cy="13258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/>
            </a:pPr>
            <a:r>
              <a:rPr lang="fr-FR" sz="15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F</a:t>
            </a:r>
            <a:r>
              <a:rPr lang="fr-FR" sz="15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igure S4: 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Total </a:t>
            </a:r>
            <a:r>
              <a:rPr lang="fr-FR" sz="1500" b="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lsr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expression in </a:t>
            </a:r>
            <a:r>
              <a:rPr lang="fr-FR" sz="1500" b="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astroglial</a:t>
            </a:r>
            <a:r>
              <a:rPr lang="fr-FR" sz="1500" b="0" i="1" dirty="0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1" dirty="0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mice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vs WT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. Box plot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presentation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of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fold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expression of total </a:t>
            </a:r>
            <a:r>
              <a:rPr lang="fr-FR" sz="150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i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dirty="0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in 3-month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old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(n = 6)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ith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respect to WT (n=6) in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hippocampus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(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Hp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) and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olfactory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bulb (OB).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tatistical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ignificance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is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hown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as **</a:t>
            </a:r>
            <a:r>
              <a:rPr lang="fr-FR" sz="150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&lt;0.01, *** </a:t>
            </a:r>
            <a:r>
              <a:rPr lang="fr-FR" sz="1500" b="0" i="1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&lt;0.001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omparing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to WT groups. </a:t>
            </a:r>
            <a:endParaRPr sz="1500" dirty="0">
              <a:solidFill>
                <a:schemeClr val="dk1"/>
              </a:solidFill>
              <a:latin typeface="Arial"/>
              <a:ea typeface="Arial"/>
              <a:cs typeface="Arial"/>
            </a:endParaRPr>
          </a:p>
          <a:p>
            <a:pPr marL="0" marR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/>
            </a:pPr>
            <a:endParaRPr sz="1500" b="1" dirty="0">
              <a:solidFill>
                <a:schemeClr val="dk1"/>
              </a:solidFill>
              <a:latin typeface="Arial"/>
              <a:ea typeface="Arial"/>
              <a:cs typeface="Arial"/>
            </a:endParaRPr>
          </a:p>
        </p:txBody>
      </p:sp>
      <p:pic>
        <p:nvPicPr>
          <p:cNvPr id="5" name="Google Shape;114;g10f1fdb07ad_0_0"/>
          <p:cNvPicPr/>
          <p:nvPr/>
        </p:nvPicPr>
        <p:blipFill>
          <a:blip r:embed="rId2">
            <a:alphaModFix/>
          </a:blip>
          <a:stretch/>
        </p:blipFill>
        <p:spPr bwMode="auto">
          <a:xfrm>
            <a:off x="3900775" y="186025"/>
            <a:ext cx="3999266" cy="43375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575603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4</cp:revision>
  <dcterms:created xsi:type="dcterms:W3CDTF">2022-01-28T21:57:26Z</dcterms:created>
  <dcterms:modified xsi:type="dcterms:W3CDTF">2022-02-05T21:27:01Z</dcterms:modified>
</cp:coreProperties>
</file>